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4"/>
  </p:notesMasterIdLst>
  <p:sldIdLst>
    <p:sldId id="266" r:id="rId2"/>
    <p:sldId id="268" r:id="rId3"/>
  </p:sldIdLst>
  <p:sldSz cx="6858000" cy="9906000" type="A4"/>
  <p:notesSz cx="6858000" cy="9144000"/>
  <p:embeddedFontLst>
    <p:embeddedFont>
      <p:font typeface="Calibri" panose="020F0502020204030204" pitchFamily="34" charset="0"/>
      <p:regular r:id="rId5"/>
      <p:bold r:id="rId6"/>
      <p:italic r:id="rId7"/>
      <p:boldItalic r:id="rId8"/>
    </p:embeddedFont>
    <p:embeddedFont>
      <p:font typeface="Calibri Light" panose="020F0302020204030204" pitchFamily="34" charset="0"/>
      <p:regular r:id="rId9"/>
      <p:italic r:id="rId10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7B57B"/>
    <a:srgbClr val="E7F5EC"/>
    <a:srgbClr val="DFF1E6"/>
    <a:srgbClr val="ECF3FA"/>
    <a:srgbClr val="D4ECDD"/>
    <a:srgbClr val="BBE1C9"/>
    <a:srgbClr val="DEEBF7"/>
    <a:srgbClr val="C7F1F5"/>
    <a:srgbClr val="6DBF8C"/>
    <a:srgbClr val="84C49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249" autoAdjust="0"/>
  </p:normalViewPr>
  <p:slideViewPr>
    <p:cSldViewPr snapToGrid="0" showGuides="1">
      <p:cViewPr>
        <p:scale>
          <a:sx n="125" d="100"/>
          <a:sy n="125" d="100"/>
        </p:scale>
        <p:origin x="552" y="-2988"/>
      </p:cViewPr>
      <p:guideLst>
        <p:guide orient="horz" pos="3143"/>
        <p:guide pos="2137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4.fntdata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font" Target="fonts/font3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2.fntdata"/><Relationship Id="rId11" Type="http://schemas.openxmlformats.org/officeDocument/2006/relationships/presProps" Target="presProps.xml"/><Relationship Id="rId5" Type="http://schemas.openxmlformats.org/officeDocument/2006/relationships/font" Target="fonts/font1.fntdata"/><Relationship Id="rId10" Type="http://schemas.openxmlformats.org/officeDocument/2006/relationships/font" Target="fonts/font6.fntdata"/><Relationship Id="rId4" Type="http://schemas.openxmlformats.org/officeDocument/2006/relationships/notesMaster" Target="notesMasters/notesMaster1.xml"/><Relationship Id="rId9" Type="http://schemas.openxmlformats.org/officeDocument/2006/relationships/font" Target="fonts/font5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6601268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2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6062036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15/02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ZoneTexte 31">
            <a:extLst>
              <a:ext uri="{FF2B5EF4-FFF2-40B4-BE49-F238E27FC236}">
                <a16:creationId xmlns:a16="http://schemas.microsoft.com/office/drawing/2014/main" id="{A7C0D85A-15EB-F03E-FA8C-59EC45B55948}"/>
              </a:ext>
            </a:extLst>
          </p:cNvPr>
          <p:cNvSpPr txBox="1"/>
          <p:nvPr/>
        </p:nvSpPr>
        <p:spPr>
          <a:xfrm>
            <a:off x="512668" y="6950708"/>
            <a:ext cx="57596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ig. S6a | Maternal genotype effects on metabolic fingerprints within chemotypes.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Exploration of the impact of maternal genotype on major terpenoid profile among chemotypes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rtial least square analyses were performed using significant LC-MS features from plants belonging to the following chemotypes: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Thu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BThu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Keto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acet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Myrox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chemotypes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nly conditions with a minimum of 3 replicates were used (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i.e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hree replicates per maternal genotype*chemotype condition). 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C34E0808-D119-C1E9-63E7-F85AA49677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2551" y="454292"/>
            <a:ext cx="2808000" cy="2968522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C4D81E5F-9A59-66C6-6AC9-DB3D8038201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2551" y="3637896"/>
            <a:ext cx="2808000" cy="2934140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CF5F3DC5-6F9D-4DF7-6BFD-A1C1BEAB6ED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297" y="454292"/>
            <a:ext cx="2808000" cy="2968522"/>
          </a:xfrm>
          <a:prstGeom prst="rect">
            <a:avLst/>
          </a:prstGeom>
        </p:spPr>
      </p:pic>
      <p:grpSp>
        <p:nvGrpSpPr>
          <p:cNvPr id="31" name="Groupe 30">
            <a:extLst>
              <a:ext uri="{FF2B5EF4-FFF2-40B4-BE49-F238E27FC236}">
                <a16:creationId xmlns:a16="http://schemas.microsoft.com/office/drawing/2014/main" id="{24E3A42B-35A7-E6EA-1A4C-DC3ED0B4AEAE}"/>
              </a:ext>
            </a:extLst>
          </p:cNvPr>
          <p:cNvGrpSpPr/>
          <p:nvPr/>
        </p:nvGrpSpPr>
        <p:grpSpPr>
          <a:xfrm>
            <a:off x="473073" y="359173"/>
            <a:ext cx="3088249" cy="307777"/>
            <a:chOff x="453840" y="359173"/>
            <a:chExt cx="3088249" cy="307777"/>
          </a:xfrm>
        </p:grpSpPr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308DC970-DEFB-6D1F-FE05-4B6A145FA980}"/>
                </a:ext>
              </a:extLst>
            </p:cNvPr>
            <p:cNvSpPr txBox="1"/>
            <p:nvPr/>
          </p:nvSpPr>
          <p:spPr>
            <a:xfrm>
              <a:off x="453840" y="359173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a</a:t>
              </a:r>
            </a:p>
          </p:txBody>
        </p:sp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BE8AB8DE-F99B-63FB-7485-7E65B212EDC3}"/>
                </a:ext>
              </a:extLst>
            </p:cNvPr>
            <p:cNvSpPr txBox="1"/>
            <p:nvPr/>
          </p:nvSpPr>
          <p:spPr>
            <a:xfrm>
              <a:off x="3290989" y="359173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b</a:t>
              </a:r>
            </a:p>
          </p:txBody>
        </p:sp>
      </p:grpSp>
      <p:pic>
        <p:nvPicPr>
          <p:cNvPr id="12" name="Image 11">
            <a:extLst>
              <a:ext uri="{FF2B5EF4-FFF2-40B4-BE49-F238E27FC236}">
                <a16:creationId xmlns:a16="http://schemas.microsoft.com/office/drawing/2014/main" id="{D9BA41B3-6812-6E86-7F4A-6B6E9769512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297" y="3620705"/>
            <a:ext cx="2808000" cy="2968522"/>
          </a:xfrm>
          <a:prstGeom prst="rect">
            <a:avLst/>
          </a:prstGeom>
        </p:spPr>
      </p:pic>
      <p:grpSp>
        <p:nvGrpSpPr>
          <p:cNvPr id="22" name="Groupe 21">
            <a:extLst>
              <a:ext uri="{FF2B5EF4-FFF2-40B4-BE49-F238E27FC236}">
                <a16:creationId xmlns:a16="http://schemas.microsoft.com/office/drawing/2014/main" id="{B16472D2-0125-F691-4C9C-609602EB1DBC}"/>
              </a:ext>
            </a:extLst>
          </p:cNvPr>
          <p:cNvGrpSpPr/>
          <p:nvPr/>
        </p:nvGrpSpPr>
        <p:grpSpPr>
          <a:xfrm>
            <a:off x="473073" y="3422854"/>
            <a:ext cx="3088249" cy="307777"/>
            <a:chOff x="453840" y="359173"/>
            <a:chExt cx="3088249" cy="307777"/>
          </a:xfrm>
        </p:grpSpPr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C407D72A-4F23-2544-81DE-75078C1A53A7}"/>
                </a:ext>
              </a:extLst>
            </p:cNvPr>
            <p:cNvSpPr txBox="1"/>
            <p:nvPr/>
          </p:nvSpPr>
          <p:spPr>
            <a:xfrm>
              <a:off x="453840" y="359173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c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457F3D50-3518-D618-5108-C70750B0B2E4}"/>
                </a:ext>
              </a:extLst>
            </p:cNvPr>
            <p:cNvSpPr txBox="1"/>
            <p:nvPr/>
          </p:nvSpPr>
          <p:spPr>
            <a:xfrm>
              <a:off x="3290989" y="359173"/>
              <a:ext cx="2511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>
                  <a:latin typeface="Arial" panose="020B0604020202090204" pitchFamily="34" charset="0"/>
                  <a:cs typeface="Arial" panose="020B0604020202090204" pitchFamily="34" charset="0"/>
                </a:rPr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667192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>
            <a:extLst>
              <a:ext uri="{FF2B5EF4-FFF2-40B4-BE49-F238E27FC236}">
                <a16:creationId xmlns:a16="http://schemas.microsoft.com/office/drawing/2014/main" id="{5FADC20D-CD0F-6959-53CC-4674BBD5D623}"/>
              </a:ext>
            </a:extLst>
          </p:cNvPr>
          <p:cNvSpPr txBox="1"/>
          <p:nvPr/>
        </p:nvSpPr>
        <p:spPr>
          <a:xfrm>
            <a:off x="473073" y="3538436"/>
            <a:ext cx="57596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ig. S6b | Maternal genotype effects on metabolic fingerprints within chemotypes.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Exploration of the impact of maternal genotype on major terpenoid profile among chemotypes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artial least square analyses were performed using significant LC-MS features from plants belonging to the following chemotypes: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Thu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BThu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Keto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acet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Myrox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) chemotypes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Only conditions with a minimum of 3 replicates were used (</a:t>
            </a:r>
            <a:r>
              <a:rPr lang="en-US" sz="800" i="1" dirty="0">
                <a:latin typeface="Arial" panose="020B0604020202020204" pitchFamily="34" charset="0"/>
                <a:cs typeface="Arial" panose="020B0604020202020204" pitchFamily="34" charset="0"/>
              </a:rPr>
              <a:t>i.e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hree replicates per maternal genotype*chemotype condition). 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13321BE5-041F-E05C-3A66-E8AD3596A74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488" y="447926"/>
            <a:ext cx="2808000" cy="2968522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308DC970-DEFB-6D1F-FE05-4B6A145FA980}"/>
              </a:ext>
            </a:extLst>
          </p:cNvPr>
          <p:cNvSpPr txBox="1"/>
          <p:nvPr/>
        </p:nvSpPr>
        <p:spPr>
          <a:xfrm>
            <a:off x="473073" y="359173"/>
            <a:ext cx="251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90204" pitchFamily="34" charset="0"/>
                <a:cs typeface="Arial" panose="020B060402020209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36127976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37</TotalTime>
  <Words>191</Words>
  <Application>Microsoft Office PowerPoint</Application>
  <PresentationFormat>Format A4 (210 x 297 mm)</PresentationFormat>
  <Paragraphs>9</Paragraphs>
  <Slides>2</Slides>
  <Notes>2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Calibri Light</vt:lpstr>
      <vt:lpstr>Calibri</vt:lpstr>
      <vt:lpstr>Arial</vt:lpstr>
      <vt:lpstr>Thème Office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520</cp:revision>
  <dcterms:created xsi:type="dcterms:W3CDTF">2020-07-29T08:33:47Z</dcterms:created>
  <dcterms:modified xsi:type="dcterms:W3CDTF">2023-02-15T14:07:33Z</dcterms:modified>
</cp:coreProperties>
</file>